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46" d="100"/>
          <a:sy n="146" d="100"/>
        </p:scale>
        <p:origin x="96" y="3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96970F-4DE8-482E-836D-43D90C3056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8555798-24B2-4462-A9B6-633CE843CA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B75BA2-AD57-42BC-AF0C-C2C262AB9D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95B69A9-52C6-49A5-85A6-223EFC249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EEBCF9-BA13-41D1-8C15-415B377A9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1381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35C36B-3D5B-4FAB-9291-0CD0FF6333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9EBFC0D-6FFC-4F30-8F57-2C1E3803BD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03ACDF-2A46-4452-A132-6997D1E63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C73B03-D207-4197-B0D5-804A9C53F6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01F536-D3C2-4AF9-B041-40A059676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009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3162D27-4447-47FB-BA5A-F7D06AB481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55EDBCE-2F9D-4E6F-93D7-3378CFF2FB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9CC250-FCFB-47C2-8361-BF2E13ADF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030E7B0-A5A1-4745-8F25-6A76721BB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C01B9B-44B6-4252-AC11-B9CAABE1B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18072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D70733-FA1A-4932-9258-B1290C95EB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096FA1-9FF7-4684-9A69-745D6CE492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6AB66A-B680-4439-954E-2FE0E7788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20736D-8E76-4D9C-85D5-42BA510B9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0C668D-8B72-4E42-9EE9-30DDD7FC7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686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7030D5-5B0D-42C6-B5E5-02381E5C36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F2AFA23-4604-4621-B18D-F0C8646693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06C109C-7AFF-4AC1-BE97-0737604E0E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CCBC3A9-36F7-4D84-8C14-68D2CB0FA8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019ACBE-ACB6-4D12-A9C5-73E96BE1A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96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2C7C5A-404C-4F25-9175-75164C22F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C4047D4-FD54-4AE1-90AB-8D8D649E7A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5877B81-B3D8-4FAB-933E-5B441C5F59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80340A-2FDB-4A66-8C00-4EF5B4A1C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948B9A9-F829-4776-BCEB-3CD99D447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9F6D48-6707-4E1F-B2EC-8CE094F58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11536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4F6AB1-72BD-4938-AF0C-9369AE66DB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14F03FC-86FC-41DB-9E8F-89BDFA56D7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4863B75-180D-44B3-8CCB-99F73D70D9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689D1BC-E7A6-4B04-8F6A-C217A49B2C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AE22A25-61A0-471D-BFBD-1B572A32E0F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1C8D80F-B630-4159-9DDF-A4971A413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272804B-E1F1-4232-8667-70EB04218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976531F-44AF-460C-927D-F6BFF0007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7795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A91168-6E97-44F1-A193-491AEA7E78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D680617-2A7A-4BCA-A97D-B1DB9F27F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6F4A840-F1E4-44DB-9B95-AC799E8A1E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EAB18B9-08A3-4BF0-B0C8-84011FF8D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4669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FE7D9C2-97FD-4105-BE2B-FBEB60E715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30B2856-7E3C-4A37-A7B3-044AC7F611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0FD0664-89D7-4B9A-8446-C7CC14D8D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1219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5D2A54-E4E7-4ECC-99AE-593C45FB77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7419255-EC44-47F8-97F1-E302CA0C42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C324B2B-25E2-481D-AF06-27812D393A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623F73C-85AF-436B-A5FA-8DC11DAEE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55C7F8-5249-4505-B1BF-DF805B401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4B74628-5C1A-4DDB-91BB-DF7236E96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46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DDDF61-C40F-4067-B726-50A0EEBC1C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1D327CD-7D40-4BB5-B6B9-BAC322E19C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9DA865E-B720-48BD-981C-8E40160B53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049968-C8B5-4C21-A9D6-A12D95ED0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58B3B3D-1A02-4B85-999B-A5696F860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7B03A47-EEA0-49C2-9452-0B04111123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224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EB57C66-31A5-4FB5-97F7-C16F3FD49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F95F0E-5363-41EB-80C3-F179A38E63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44E141-B862-4004-95A7-CD501C0EC4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BEE4EC-DFD9-4703-A894-FCB73320ED60}" type="datetimeFigureOut">
              <a:rPr lang="zh-CN" altLang="en-US" smtClean="0"/>
              <a:t>2022/3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8AA8776-8DC0-4EBA-87F2-3B8F1B3AB4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D67954-2B4C-4403-A322-B1621BB7DD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36C4DA-EDB3-4FDE-839D-42BE5E6998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889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217EEC-CB1D-44AC-8292-2356C2CB2D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0" y="0"/>
            <a:ext cx="12192000" cy="847839"/>
          </a:xfrm>
        </p:spPr>
        <p:txBody>
          <a:bodyPr>
            <a:normAutofit/>
          </a:bodyPr>
          <a:lstStyle/>
          <a:p>
            <a:pPr algn="l"/>
            <a:r>
              <a:rPr lang="en-US" altLang="zh-CN" sz="4000" b="1">
                <a:latin typeface="Arial" panose="020B0604020202020204" pitchFamily="34" charset="0"/>
                <a:cs typeface="Arial" panose="020B0604020202020204" pitchFamily="34" charset="0"/>
              </a:rPr>
              <a:t>Figure 1 </a:t>
            </a:r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original, full-length gel and blot 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D7D3153-D324-4536-8BDD-8C52504DB11F}"/>
              </a:ext>
            </a:extLst>
          </p:cNvPr>
          <p:cNvSpPr txBox="1"/>
          <p:nvPr/>
        </p:nvSpPr>
        <p:spPr>
          <a:xfrm>
            <a:off x="244187" y="545506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D1E6F33-DB19-49EF-977F-075472027770}"/>
              </a:ext>
            </a:extLst>
          </p:cNvPr>
          <p:cNvSpPr txBox="1"/>
          <p:nvPr/>
        </p:nvSpPr>
        <p:spPr>
          <a:xfrm>
            <a:off x="188626" y="3441656"/>
            <a:ext cx="10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-PARP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76970C87-A0C8-4C08-9C05-4219046B7D9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3" t="18100" r="11002" b="43965"/>
          <a:stretch/>
        </p:blipFill>
        <p:spPr>
          <a:xfrm>
            <a:off x="1684737" y="1868405"/>
            <a:ext cx="7007513" cy="492182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9EAA0410-F3ED-4219-BD9D-B39CE2A401D1}"/>
              </a:ext>
            </a:extLst>
          </p:cNvPr>
          <p:cNvSpPr txBox="1"/>
          <p:nvPr/>
        </p:nvSpPr>
        <p:spPr>
          <a:xfrm>
            <a:off x="3007584" y="140183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6F44B81-9FBE-4FF5-9100-F46BAF58FBFF}"/>
              </a:ext>
            </a:extLst>
          </p:cNvPr>
          <p:cNvSpPr txBox="1"/>
          <p:nvPr/>
        </p:nvSpPr>
        <p:spPr>
          <a:xfrm>
            <a:off x="3720328" y="140617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A8E6B88-44FF-473D-8050-7E0BCE6E02F8}"/>
              </a:ext>
            </a:extLst>
          </p:cNvPr>
          <p:cNvSpPr txBox="1"/>
          <p:nvPr/>
        </p:nvSpPr>
        <p:spPr>
          <a:xfrm>
            <a:off x="4373610" y="140183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A5586AA-573F-41A1-98AB-657F96E5D5A7}"/>
              </a:ext>
            </a:extLst>
          </p:cNvPr>
          <p:cNvSpPr txBox="1"/>
          <p:nvPr/>
        </p:nvSpPr>
        <p:spPr>
          <a:xfrm>
            <a:off x="4970079" y="140183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E68CF6A-B2A1-4A0E-AC27-3F975CB453AF}"/>
              </a:ext>
            </a:extLst>
          </p:cNvPr>
          <p:cNvSpPr txBox="1"/>
          <p:nvPr/>
        </p:nvSpPr>
        <p:spPr>
          <a:xfrm>
            <a:off x="5696875" y="140183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24C2BFA-29BF-4806-AA10-2E414C12BFB5}"/>
              </a:ext>
            </a:extLst>
          </p:cNvPr>
          <p:cNvSpPr txBox="1"/>
          <p:nvPr/>
        </p:nvSpPr>
        <p:spPr>
          <a:xfrm>
            <a:off x="6301998" y="140183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F465A59-BC14-4837-9A65-51F6F22C016B}"/>
              </a:ext>
            </a:extLst>
          </p:cNvPr>
          <p:cNvSpPr txBox="1"/>
          <p:nvPr/>
        </p:nvSpPr>
        <p:spPr>
          <a:xfrm>
            <a:off x="6971948" y="140183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856158F-0E53-46B3-B405-DD1614E336A4}"/>
              </a:ext>
            </a:extLst>
          </p:cNvPr>
          <p:cNvSpPr txBox="1"/>
          <p:nvPr/>
        </p:nvSpPr>
        <p:spPr>
          <a:xfrm>
            <a:off x="7558878" y="140183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29FCB08-159F-4F55-94D0-00BAF9CC380E}"/>
              </a:ext>
            </a:extLst>
          </p:cNvPr>
          <p:cNvSpPr txBox="1"/>
          <p:nvPr/>
        </p:nvSpPr>
        <p:spPr>
          <a:xfrm>
            <a:off x="3688902" y="935269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0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237724C5-4137-4676-92F5-9FEEF6B9D481}"/>
              </a:ext>
            </a:extLst>
          </p:cNvPr>
          <p:cNvCxnSpPr/>
          <p:nvPr/>
        </p:nvCxnSpPr>
        <p:spPr>
          <a:xfrm>
            <a:off x="2908469" y="1334879"/>
            <a:ext cx="2535811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>
            <a:extLst>
              <a:ext uri="{FF2B5EF4-FFF2-40B4-BE49-F238E27FC236}">
                <a16:creationId xmlns:a16="http://schemas.microsoft.com/office/drawing/2014/main" id="{C9390C2D-04CB-419D-BC21-D6CFFDB0474E}"/>
              </a:ext>
            </a:extLst>
          </p:cNvPr>
          <p:cNvSpPr txBox="1"/>
          <p:nvPr/>
        </p:nvSpPr>
        <p:spPr>
          <a:xfrm>
            <a:off x="6371156" y="935269"/>
            <a:ext cx="846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接连接符 28">
            <a:extLst>
              <a:ext uri="{FF2B5EF4-FFF2-40B4-BE49-F238E27FC236}">
                <a16:creationId xmlns:a16="http://schemas.microsoft.com/office/drawing/2014/main" id="{E32E57E0-18E5-4A78-915E-B8EDED59D7AA}"/>
              </a:ext>
            </a:extLst>
          </p:cNvPr>
          <p:cNvCxnSpPr/>
          <p:nvPr/>
        </p:nvCxnSpPr>
        <p:spPr>
          <a:xfrm>
            <a:off x="5590723" y="1334879"/>
            <a:ext cx="2535811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467E9AD9-660E-458D-9859-517CA8BAF5F2}"/>
              </a:ext>
            </a:extLst>
          </p:cNvPr>
          <p:cNvSpPr txBox="1"/>
          <p:nvPr/>
        </p:nvSpPr>
        <p:spPr>
          <a:xfrm>
            <a:off x="8980758" y="2729017"/>
            <a:ext cx="3816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.</a:t>
            </a:r>
            <a:r>
              <a:rPr lang="zh-CN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80AC74DD-F3A3-4763-9023-4E4F41D026CD}"/>
              </a:ext>
            </a:extLst>
          </p:cNvPr>
          <p:cNvSpPr txBox="1"/>
          <p:nvPr/>
        </p:nvSpPr>
        <p:spPr>
          <a:xfrm>
            <a:off x="8980758" y="3429902"/>
            <a:ext cx="3816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. CT-707 3</a:t>
            </a:r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μ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508A192-56D9-4E02-B939-7A85A9716D90}"/>
              </a:ext>
            </a:extLst>
          </p:cNvPr>
          <p:cNvSpPr txBox="1"/>
          <p:nvPr/>
        </p:nvSpPr>
        <p:spPr>
          <a:xfrm>
            <a:off x="8980757" y="4129710"/>
            <a:ext cx="38164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. Sorafenib 20</a:t>
            </a:r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μ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 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3526EF6F-691A-48B2-B5F7-27EDDBCB0CA0}"/>
              </a:ext>
            </a:extLst>
          </p:cNvPr>
          <p:cNvSpPr txBox="1"/>
          <p:nvPr/>
        </p:nvSpPr>
        <p:spPr>
          <a:xfrm>
            <a:off x="8980757" y="4808737"/>
            <a:ext cx="227507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4. CT-707 3</a:t>
            </a:r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μ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+ Sorafenib 20</a:t>
            </a:r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 μ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40313AC2-BB47-4871-B0B6-C1936EB862C4}"/>
              </a:ext>
            </a:extLst>
          </p:cNvPr>
          <p:cNvSpPr/>
          <p:nvPr/>
        </p:nvSpPr>
        <p:spPr>
          <a:xfrm>
            <a:off x="5509750" y="3023839"/>
            <a:ext cx="2807855" cy="270270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9DBCC4D-AA7E-4F31-89B3-ADF9716A6D34}"/>
              </a:ext>
            </a:extLst>
          </p:cNvPr>
          <p:cNvSpPr txBox="1"/>
          <p:nvPr/>
        </p:nvSpPr>
        <p:spPr>
          <a:xfrm>
            <a:off x="9041616" y="5845278"/>
            <a:ext cx="255384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-length blots/gels for Figure 3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标题 1">
            <a:extLst>
              <a:ext uri="{FF2B5EF4-FFF2-40B4-BE49-F238E27FC236}">
                <a16:creationId xmlns:a16="http://schemas.microsoft.com/office/drawing/2014/main" id="{4645BAA0-F142-4CB7-8B15-C09EBE1B62BE}"/>
              </a:ext>
            </a:extLst>
          </p:cNvPr>
          <p:cNvSpPr txBox="1">
            <a:spLocks/>
          </p:cNvSpPr>
          <p:nvPr/>
        </p:nvSpPr>
        <p:spPr>
          <a:xfrm>
            <a:off x="246971" y="774328"/>
            <a:ext cx="549729" cy="84783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3629467-DA0C-4713-8675-209FDF8C8732}"/>
              </a:ext>
            </a:extLst>
          </p:cNvPr>
          <p:cNvSpPr txBox="1"/>
          <p:nvPr/>
        </p:nvSpPr>
        <p:spPr>
          <a:xfrm>
            <a:off x="1269411" y="517972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0116ADE-5AB0-4B82-A27F-43EEA1629665}"/>
              </a:ext>
            </a:extLst>
          </p:cNvPr>
          <p:cNvSpPr txBox="1"/>
          <p:nvPr/>
        </p:nvSpPr>
        <p:spPr>
          <a:xfrm>
            <a:off x="1265589" y="4761773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DB125A5-F713-4CA8-97D9-71C8B0279970}"/>
              </a:ext>
            </a:extLst>
          </p:cNvPr>
          <p:cNvSpPr txBox="1"/>
          <p:nvPr/>
        </p:nvSpPr>
        <p:spPr>
          <a:xfrm>
            <a:off x="1189128" y="415335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D0594E9C-046E-4812-A714-8761D711EFA7}"/>
              </a:ext>
            </a:extLst>
          </p:cNvPr>
          <p:cNvSpPr txBox="1"/>
          <p:nvPr/>
        </p:nvSpPr>
        <p:spPr>
          <a:xfrm>
            <a:off x="1189128" y="376308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7A3EC44-F4C5-4D68-986B-DE02A232D34C}"/>
              </a:ext>
            </a:extLst>
          </p:cNvPr>
          <p:cNvSpPr txBox="1"/>
          <p:nvPr/>
        </p:nvSpPr>
        <p:spPr>
          <a:xfrm>
            <a:off x="1125007" y="3478379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EB535E61-29F1-456E-9924-CC5E26CFFB87}"/>
              </a:ext>
            </a:extLst>
          </p:cNvPr>
          <p:cNvSpPr txBox="1"/>
          <p:nvPr/>
        </p:nvSpPr>
        <p:spPr>
          <a:xfrm>
            <a:off x="1125007" y="3211617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ECB629FA-768E-474A-A03C-E688F8E9FB80}"/>
              </a:ext>
            </a:extLst>
          </p:cNvPr>
          <p:cNvSpPr txBox="1"/>
          <p:nvPr/>
        </p:nvSpPr>
        <p:spPr>
          <a:xfrm>
            <a:off x="1122796" y="3002001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AF13C676-4982-4A27-AF05-101F69AF5F81}"/>
              </a:ext>
            </a:extLst>
          </p:cNvPr>
          <p:cNvCxnSpPr/>
          <p:nvPr/>
        </p:nvCxnSpPr>
        <p:spPr>
          <a:xfrm>
            <a:off x="1630274" y="3212008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0B086F74-0744-45EF-9D07-5010292C5D1A}"/>
              </a:ext>
            </a:extLst>
          </p:cNvPr>
          <p:cNvCxnSpPr>
            <a:cxnSpLocks/>
          </p:cNvCxnSpPr>
          <p:nvPr/>
        </p:nvCxnSpPr>
        <p:spPr>
          <a:xfrm>
            <a:off x="1630274" y="3396283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9799CD57-4614-49E2-8065-212CEFC9453D}"/>
              </a:ext>
            </a:extLst>
          </p:cNvPr>
          <p:cNvCxnSpPr>
            <a:cxnSpLocks/>
          </p:cNvCxnSpPr>
          <p:nvPr/>
        </p:nvCxnSpPr>
        <p:spPr>
          <a:xfrm>
            <a:off x="1627486" y="3671694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111BDDF5-DD8A-4F4C-91AE-7245C27CCE28}"/>
              </a:ext>
            </a:extLst>
          </p:cNvPr>
          <p:cNvCxnSpPr>
            <a:cxnSpLocks/>
          </p:cNvCxnSpPr>
          <p:nvPr/>
        </p:nvCxnSpPr>
        <p:spPr>
          <a:xfrm>
            <a:off x="1606261" y="3944432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D7329C9B-19F7-41DB-A10D-66EEF3F37C35}"/>
              </a:ext>
            </a:extLst>
          </p:cNvPr>
          <p:cNvCxnSpPr>
            <a:cxnSpLocks/>
          </p:cNvCxnSpPr>
          <p:nvPr/>
        </p:nvCxnSpPr>
        <p:spPr>
          <a:xfrm>
            <a:off x="1587887" y="4323084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4C08E3B5-8502-45FF-9E7E-3EEA90A2DD9E}"/>
              </a:ext>
            </a:extLst>
          </p:cNvPr>
          <p:cNvCxnSpPr>
            <a:cxnSpLocks/>
          </p:cNvCxnSpPr>
          <p:nvPr/>
        </p:nvCxnSpPr>
        <p:spPr>
          <a:xfrm>
            <a:off x="1627486" y="4963164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38153D31-910A-4829-A33A-96369D998C4C}"/>
              </a:ext>
            </a:extLst>
          </p:cNvPr>
          <p:cNvCxnSpPr>
            <a:cxnSpLocks/>
          </p:cNvCxnSpPr>
          <p:nvPr/>
        </p:nvCxnSpPr>
        <p:spPr>
          <a:xfrm>
            <a:off x="1606261" y="5364389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接连接符 46">
            <a:extLst>
              <a:ext uri="{FF2B5EF4-FFF2-40B4-BE49-F238E27FC236}">
                <a16:creationId xmlns:a16="http://schemas.microsoft.com/office/drawing/2014/main" id="{8E8DE945-B0BA-46B8-8F2D-492CF4A424D7}"/>
              </a:ext>
            </a:extLst>
          </p:cNvPr>
          <p:cNvCxnSpPr>
            <a:cxnSpLocks/>
          </p:cNvCxnSpPr>
          <p:nvPr/>
        </p:nvCxnSpPr>
        <p:spPr>
          <a:xfrm>
            <a:off x="1587887" y="5947863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66163428-19C5-4BF7-87E7-3E5BFC7C4816}"/>
              </a:ext>
            </a:extLst>
          </p:cNvPr>
          <p:cNvCxnSpPr>
            <a:cxnSpLocks/>
          </p:cNvCxnSpPr>
          <p:nvPr/>
        </p:nvCxnSpPr>
        <p:spPr>
          <a:xfrm>
            <a:off x="1581901" y="6648903"/>
            <a:ext cx="208592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E9799AB9-0677-4753-9D74-DAE13BA1166B}"/>
              </a:ext>
            </a:extLst>
          </p:cNvPr>
          <p:cNvSpPr txBox="1"/>
          <p:nvPr/>
        </p:nvSpPr>
        <p:spPr>
          <a:xfrm>
            <a:off x="1265589" y="5744386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6CDAFA8-CCA1-467B-8059-6693243E7E0B}"/>
              </a:ext>
            </a:extLst>
          </p:cNvPr>
          <p:cNvSpPr txBox="1"/>
          <p:nvPr/>
        </p:nvSpPr>
        <p:spPr>
          <a:xfrm>
            <a:off x="1252601" y="645305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1528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09BD281-8366-41B7-AE4B-2DB59DA07F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5" t="4830" r="21411" b="55337"/>
          <a:stretch/>
        </p:blipFill>
        <p:spPr>
          <a:xfrm>
            <a:off x="1844830" y="754601"/>
            <a:ext cx="6797298" cy="511711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D1E6F33-DB19-49EF-977F-075472027770}"/>
              </a:ext>
            </a:extLst>
          </p:cNvPr>
          <p:cNvSpPr txBox="1"/>
          <p:nvPr/>
        </p:nvSpPr>
        <p:spPr>
          <a:xfrm>
            <a:off x="1056242" y="4087929"/>
            <a:ext cx="637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EAA0410-F3ED-4219-BD9D-B39CE2A401D1}"/>
              </a:ext>
            </a:extLst>
          </p:cNvPr>
          <p:cNvSpPr txBox="1"/>
          <p:nvPr/>
        </p:nvSpPr>
        <p:spPr>
          <a:xfrm>
            <a:off x="2709030" y="222575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6F44B81-9FBE-4FF5-9100-F46BAF58FBFF}"/>
              </a:ext>
            </a:extLst>
          </p:cNvPr>
          <p:cNvSpPr txBox="1"/>
          <p:nvPr/>
        </p:nvSpPr>
        <p:spPr>
          <a:xfrm>
            <a:off x="3421774" y="223009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A8E6B88-44FF-473D-8050-7E0BCE6E02F8}"/>
              </a:ext>
            </a:extLst>
          </p:cNvPr>
          <p:cNvSpPr txBox="1"/>
          <p:nvPr/>
        </p:nvSpPr>
        <p:spPr>
          <a:xfrm>
            <a:off x="4075056" y="2225759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A5586AA-573F-41A1-98AB-657F96E5D5A7}"/>
              </a:ext>
            </a:extLst>
          </p:cNvPr>
          <p:cNvSpPr txBox="1"/>
          <p:nvPr/>
        </p:nvSpPr>
        <p:spPr>
          <a:xfrm>
            <a:off x="4671525" y="2225759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E68CF6A-B2A1-4A0E-AC27-3F975CB453AF}"/>
              </a:ext>
            </a:extLst>
          </p:cNvPr>
          <p:cNvSpPr txBox="1"/>
          <p:nvPr/>
        </p:nvSpPr>
        <p:spPr>
          <a:xfrm>
            <a:off x="5243479" y="222575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29FCB08-159F-4F55-94D0-00BAF9CC380E}"/>
              </a:ext>
            </a:extLst>
          </p:cNvPr>
          <p:cNvSpPr txBox="1"/>
          <p:nvPr/>
        </p:nvSpPr>
        <p:spPr>
          <a:xfrm>
            <a:off x="3491563" y="1865304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MMC-7721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8A13868-AC10-4AD1-BE67-3F88CBEF757C}"/>
              </a:ext>
            </a:extLst>
          </p:cNvPr>
          <p:cNvSpPr txBox="1"/>
          <p:nvPr/>
        </p:nvSpPr>
        <p:spPr>
          <a:xfrm>
            <a:off x="999893" y="3059668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0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E1D63A5-01F6-4F93-993B-69EA02DD7AE8}"/>
              </a:ext>
            </a:extLst>
          </p:cNvPr>
          <p:cNvSpPr txBox="1"/>
          <p:nvPr/>
        </p:nvSpPr>
        <p:spPr>
          <a:xfrm>
            <a:off x="999893" y="3466336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FDE9411-A424-4D3F-B9F4-A36353545863}"/>
              </a:ext>
            </a:extLst>
          </p:cNvPr>
          <p:cNvSpPr txBox="1"/>
          <p:nvPr/>
        </p:nvSpPr>
        <p:spPr>
          <a:xfrm>
            <a:off x="999894" y="2227844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or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D0DDE9-0C7F-44A9-93B7-0EB6F4122774}"/>
              </a:ext>
            </a:extLst>
          </p:cNvPr>
          <p:cNvSpPr txBox="1"/>
          <p:nvPr/>
        </p:nvSpPr>
        <p:spPr>
          <a:xfrm>
            <a:off x="999893" y="2643756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-70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13EFA0E-3D13-4F1B-8515-FF8D9AF84306}"/>
              </a:ext>
            </a:extLst>
          </p:cNvPr>
          <p:cNvSpPr txBox="1"/>
          <p:nvPr/>
        </p:nvSpPr>
        <p:spPr>
          <a:xfrm>
            <a:off x="2709030" y="264375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A6A03EE-F63A-4745-A327-D99934606453}"/>
              </a:ext>
            </a:extLst>
          </p:cNvPr>
          <p:cNvSpPr txBox="1"/>
          <p:nvPr/>
        </p:nvSpPr>
        <p:spPr>
          <a:xfrm>
            <a:off x="3421774" y="264809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D2F1D50-A19A-4B86-BC06-CE11C0C72238}"/>
              </a:ext>
            </a:extLst>
          </p:cNvPr>
          <p:cNvSpPr txBox="1"/>
          <p:nvPr/>
        </p:nvSpPr>
        <p:spPr>
          <a:xfrm>
            <a:off x="4075056" y="264375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BE630E1-0E5E-4F66-9A00-D5184FB16E6C}"/>
              </a:ext>
            </a:extLst>
          </p:cNvPr>
          <p:cNvSpPr txBox="1"/>
          <p:nvPr/>
        </p:nvSpPr>
        <p:spPr>
          <a:xfrm>
            <a:off x="4671525" y="264375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905A863-71EF-4EB9-8987-0FA2AFB475AF}"/>
              </a:ext>
            </a:extLst>
          </p:cNvPr>
          <p:cNvSpPr txBox="1"/>
          <p:nvPr/>
        </p:nvSpPr>
        <p:spPr>
          <a:xfrm>
            <a:off x="5243479" y="264375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AE2F21E-6C7E-46DD-A700-D582DFD28A4F}"/>
              </a:ext>
            </a:extLst>
          </p:cNvPr>
          <p:cNvSpPr txBox="1"/>
          <p:nvPr/>
        </p:nvSpPr>
        <p:spPr>
          <a:xfrm>
            <a:off x="2709030" y="3059668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1756BC8-29E7-45DB-A962-E0C598C7A612}"/>
              </a:ext>
            </a:extLst>
          </p:cNvPr>
          <p:cNvSpPr txBox="1"/>
          <p:nvPr/>
        </p:nvSpPr>
        <p:spPr>
          <a:xfrm>
            <a:off x="3421774" y="3064008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A904170-2D9B-4C87-B122-6B12C34BC5BA}"/>
              </a:ext>
            </a:extLst>
          </p:cNvPr>
          <p:cNvSpPr txBox="1"/>
          <p:nvPr/>
        </p:nvSpPr>
        <p:spPr>
          <a:xfrm>
            <a:off x="4075056" y="3059668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DD8C397-A746-46B0-B338-71CE09BDE938}"/>
              </a:ext>
            </a:extLst>
          </p:cNvPr>
          <p:cNvSpPr txBox="1"/>
          <p:nvPr/>
        </p:nvSpPr>
        <p:spPr>
          <a:xfrm>
            <a:off x="4671525" y="3059668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8F2FF2E-A278-4053-AE63-A74EB545D6C6}"/>
              </a:ext>
            </a:extLst>
          </p:cNvPr>
          <p:cNvSpPr txBox="1"/>
          <p:nvPr/>
        </p:nvSpPr>
        <p:spPr>
          <a:xfrm>
            <a:off x="5243479" y="3059668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4ECB22F9-8E47-4571-AAC4-27056333A04C}"/>
              </a:ext>
            </a:extLst>
          </p:cNvPr>
          <p:cNvSpPr txBox="1"/>
          <p:nvPr/>
        </p:nvSpPr>
        <p:spPr>
          <a:xfrm>
            <a:off x="2709030" y="346199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9E789FD-3DD9-43C0-9803-A1439D3AD4E6}"/>
              </a:ext>
            </a:extLst>
          </p:cNvPr>
          <p:cNvSpPr txBox="1"/>
          <p:nvPr/>
        </p:nvSpPr>
        <p:spPr>
          <a:xfrm>
            <a:off x="3421774" y="346633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D9F78E0-92A5-4C81-AB2C-98FE2BC70B94}"/>
              </a:ext>
            </a:extLst>
          </p:cNvPr>
          <p:cNvSpPr txBox="1"/>
          <p:nvPr/>
        </p:nvSpPr>
        <p:spPr>
          <a:xfrm>
            <a:off x="4075056" y="346199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ADA3A14-8CF1-4417-AB43-C9DCA9AF9F3E}"/>
              </a:ext>
            </a:extLst>
          </p:cNvPr>
          <p:cNvSpPr txBox="1"/>
          <p:nvPr/>
        </p:nvSpPr>
        <p:spPr>
          <a:xfrm>
            <a:off x="4671525" y="346199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F701FFD-9AA4-43C6-A877-003F7C976116}"/>
              </a:ext>
            </a:extLst>
          </p:cNvPr>
          <p:cNvSpPr txBox="1"/>
          <p:nvPr/>
        </p:nvSpPr>
        <p:spPr>
          <a:xfrm>
            <a:off x="5243479" y="346199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17FF1053-1557-4CFB-81E0-CF7EA7CBB5FA}"/>
              </a:ext>
            </a:extLst>
          </p:cNvPr>
          <p:cNvSpPr/>
          <p:nvPr/>
        </p:nvSpPr>
        <p:spPr>
          <a:xfrm>
            <a:off x="2353882" y="4087929"/>
            <a:ext cx="3755254" cy="71489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66740A0-4314-42A3-AC83-079CE81281AD}"/>
              </a:ext>
            </a:extLst>
          </p:cNvPr>
          <p:cNvSpPr txBox="1"/>
          <p:nvPr/>
        </p:nvSpPr>
        <p:spPr>
          <a:xfrm>
            <a:off x="3383219" y="6099568"/>
            <a:ext cx="3982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-length blots/gels for 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标题 1">
            <a:extLst>
              <a:ext uri="{FF2B5EF4-FFF2-40B4-BE49-F238E27FC236}">
                <a16:creationId xmlns:a16="http://schemas.microsoft.com/office/drawing/2014/main" id="{F5E38AE5-977D-4FA1-A676-04E914BF0AED}"/>
              </a:ext>
            </a:extLst>
          </p:cNvPr>
          <p:cNvSpPr txBox="1">
            <a:spLocks/>
          </p:cNvSpPr>
          <p:nvPr/>
        </p:nvSpPr>
        <p:spPr>
          <a:xfrm>
            <a:off x="418421" y="0"/>
            <a:ext cx="549729" cy="84783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7868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5275DBE1-DEA2-4636-880F-1F94F444D31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95" t="10127" r="13434" b="50128"/>
          <a:stretch/>
        </p:blipFill>
        <p:spPr>
          <a:xfrm rot="21272239">
            <a:off x="2778499" y="386431"/>
            <a:ext cx="7288501" cy="560444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D1E6F33-DB19-49EF-977F-075472027770}"/>
              </a:ext>
            </a:extLst>
          </p:cNvPr>
          <p:cNvSpPr txBox="1"/>
          <p:nvPr/>
        </p:nvSpPr>
        <p:spPr>
          <a:xfrm>
            <a:off x="2080165" y="4315756"/>
            <a:ext cx="1621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P-YAP (S127)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EAA0410-F3ED-4219-BD9D-B39CE2A401D1}"/>
              </a:ext>
            </a:extLst>
          </p:cNvPr>
          <p:cNvSpPr txBox="1"/>
          <p:nvPr/>
        </p:nvSpPr>
        <p:spPr>
          <a:xfrm>
            <a:off x="4200478" y="167093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6F44B81-9FBE-4FF5-9100-F46BAF58FBFF}"/>
              </a:ext>
            </a:extLst>
          </p:cNvPr>
          <p:cNvSpPr txBox="1"/>
          <p:nvPr/>
        </p:nvSpPr>
        <p:spPr>
          <a:xfrm>
            <a:off x="4913222" y="167527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A8E6B88-44FF-473D-8050-7E0BCE6E02F8}"/>
              </a:ext>
            </a:extLst>
          </p:cNvPr>
          <p:cNvSpPr txBox="1"/>
          <p:nvPr/>
        </p:nvSpPr>
        <p:spPr>
          <a:xfrm>
            <a:off x="5566504" y="167093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A5586AA-573F-41A1-98AB-657F96E5D5A7}"/>
              </a:ext>
            </a:extLst>
          </p:cNvPr>
          <p:cNvSpPr txBox="1"/>
          <p:nvPr/>
        </p:nvSpPr>
        <p:spPr>
          <a:xfrm>
            <a:off x="6162973" y="1670936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E68CF6A-B2A1-4A0E-AC27-3F975CB453AF}"/>
              </a:ext>
            </a:extLst>
          </p:cNvPr>
          <p:cNvSpPr txBox="1"/>
          <p:nvPr/>
        </p:nvSpPr>
        <p:spPr>
          <a:xfrm>
            <a:off x="6734927" y="1670936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29FCB08-159F-4F55-94D0-00BAF9CC380E}"/>
              </a:ext>
            </a:extLst>
          </p:cNvPr>
          <p:cNvSpPr txBox="1"/>
          <p:nvPr/>
        </p:nvSpPr>
        <p:spPr>
          <a:xfrm>
            <a:off x="4983011" y="1310481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MMC-7721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8A13868-AC10-4AD1-BE67-3F88CBEF757C}"/>
              </a:ext>
            </a:extLst>
          </p:cNvPr>
          <p:cNvSpPr txBox="1"/>
          <p:nvPr/>
        </p:nvSpPr>
        <p:spPr>
          <a:xfrm>
            <a:off x="2491341" y="2504845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0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E1D63A5-01F6-4F93-993B-69EA02DD7AE8}"/>
              </a:ext>
            </a:extLst>
          </p:cNvPr>
          <p:cNvSpPr txBox="1"/>
          <p:nvPr/>
        </p:nvSpPr>
        <p:spPr>
          <a:xfrm>
            <a:off x="2491341" y="2911513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FDE9411-A424-4D3F-B9F4-A36353545863}"/>
              </a:ext>
            </a:extLst>
          </p:cNvPr>
          <p:cNvSpPr txBox="1"/>
          <p:nvPr/>
        </p:nvSpPr>
        <p:spPr>
          <a:xfrm>
            <a:off x="2491342" y="1673021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or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D0DDE9-0C7F-44A9-93B7-0EB6F4122774}"/>
              </a:ext>
            </a:extLst>
          </p:cNvPr>
          <p:cNvSpPr txBox="1"/>
          <p:nvPr/>
        </p:nvSpPr>
        <p:spPr>
          <a:xfrm>
            <a:off x="2491341" y="2088933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-70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13EFA0E-3D13-4F1B-8515-FF8D9AF84306}"/>
              </a:ext>
            </a:extLst>
          </p:cNvPr>
          <p:cNvSpPr txBox="1"/>
          <p:nvPr/>
        </p:nvSpPr>
        <p:spPr>
          <a:xfrm>
            <a:off x="4200478" y="208893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A6A03EE-F63A-4745-A327-D99934606453}"/>
              </a:ext>
            </a:extLst>
          </p:cNvPr>
          <p:cNvSpPr txBox="1"/>
          <p:nvPr/>
        </p:nvSpPr>
        <p:spPr>
          <a:xfrm>
            <a:off x="4913222" y="209327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D2F1D50-A19A-4B86-BC06-CE11C0C72238}"/>
              </a:ext>
            </a:extLst>
          </p:cNvPr>
          <p:cNvSpPr txBox="1"/>
          <p:nvPr/>
        </p:nvSpPr>
        <p:spPr>
          <a:xfrm>
            <a:off x="5566504" y="2088933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BE630E1-0E5E-4F66-9A00-D5184FB16E6C}"/>
              </a:ext>
            </a:extLst>
          </p:cNvPr>
          <p:cNvSpPr txBox="1"/>
          <p:nvPr/>
        </p:nvSpPr>
        <p:spPr>
          <a:xfrm>
            <a:off x="6162973" y="2088933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905A863-71EF-4EB9-8987-0FA2AFB475AF}"/>
              </a:ext>
            </a:extLst>
          </p:cNvPr>
          <p:cNvSpPr txBox="1"/>
          <p:nvPr/>
        </p:nvSpPr>
        <p:spPr>
          <a:xfrm>
            <a:off x="6734927" y="208893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AE2F21E-6C7E-46DD-A700-D582DFD28A4F}"/>
              </a:ext>
            </a:extLst>
          </p:cNvPr>
          <p:cNvSpPr txBox="1"/>
          <p:nvPr/>
        </p:nvSpPr>
        <p:spPr>
          <a:xfrm>
            <a:off x="4200478" y="2504845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1756BC8-29E7-45DB-A962-E0C598C7A612}"/>
              </a:ext>
            </a:extLst>
          </p:cNvPr>
          <p:cNvSpPr txBox="1"/>
          <p:nvPr/>
        </p:nvSpPr>
        <p:spPr>
          <a:xfrm>
            <a:off x="4913222" y="2509185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A904170-2D9B-4C87-B122-6B12C34BC5BA}"/>
              </a:ext>
            </a:extLst>
          </p:cNvPr>
          <p:cNvSpPr txBox="1"/>
          <p:nvPr/>
        </p:nvSpPr>
        <p:spPr>
          <a:xfrm>
            <a:off x="5566504" y="2504845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DD8C397-A746-46B0-B338-71CE09BDE938}"/>
              </a:ext>
            </a:extLst>
          </p:cNvPr>
          <p:cNvSpPr txBox="1"/>
          <p:nvPr/>
        </p:nvSpPr>
        <p:spPr>
          <a:xfrm>
            <a:off x="6162973" y="2504845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8F2FF2E-A278-4053-AE63-A74EB545D6C6}"/>
              </a:ext>
            </a:extLst>
          </p:cNvPr>
          <p:cNvSpPr txBox="1"/>
          <p:nvPr/>
        </p:nvSpPr>
        <p:spPr>
          <a:xfrm>
            <a:off x="6734927" y="2504845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4ECB22F9-8E47-4571-AAC4-27056333A04C}"/>
              </a:ext>
            </a:extLst>
          </p:cNvPr>
          <p:cNvSpPr txBox="1"/>
          <p:nvPr/>
        </p:nvSpPr>
        <p:spPr>
          <a:xfrm>
            <a:off x="4200478" y="2907173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9E789FD-3DD9-43C0-9803-A1439D3AD4E6}"/>
              </a:ext>
            </a:extLst>
          </p:cNvPr>
          <p:cNvSpPr txBox="1"/>
          <p:nvPr/>
        </p:nvSpPr>
        <p:spPr>
          <a:xfrm>
            <a:off x="4913222" y="291151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D9F78E0-92A5-4C81-AB2C-98FE2BC70B94}"/>
              </a:ext>
            </a:extLst>
          </p:cNvPr>
          <p:cNvSpPr txBox="1"/>
          <p:nvPr/>
        </p:nvSpPr>
        <p:spPr>
          <a:xfrm>
            <a:off x="5566504" y="2907173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ADA3A14-8CF1-4417-AB43-C9DCA9AF9F3E}"/>
              </a:ext>
            </a:extLst>
          </p:cNvPr>
          <p:cNvSpPr txBox="1"/>
          <p:nvPr/>
        </p:nvSpPr>
        <p:spPr>
          <a:xfrm>
            <a:off x="6162973" y="2907173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F701FFD-9AA4-43C6-A877-003F7C976116}"/>
              </a:ext>
            </a:extLst>
          </p:cNvPr>
          <p:cNvSpPr txBox="1"/>
          <p:nvPr/>
        </p:nvSpPr>
        <p:spPr>
          <a:xfrm>
            <a:off x="6734927" y="2907173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EDD0E7DE-CBAA-45AF-ABCD-E55DF5C06574}"/>
              </a:ext>
            </a:extLst>
          </p:cNvPr>
          <p:cNvSpPr/>
          <p:nvPr/>
        </p:nvSpPr>
        <p:spPr>
          <a:xfrm>
            <a:off x="3776256" y="4083729"/>
            <a:ext cx="3755254" cy="71489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5389F6F-6BF2-40D4-867F-0E5BD15008BE}"/>
              </a:ext>
            </a:extLst>
          </p:cNvPr>
          <p:cNvSpPr txBox="1"/>
          <p:nvPr/>
        </p:nvSpPr>
        <p:spPr>
          <a:xfrm>
            <a:off x="3383219" y="6099568"/>
            <a:ext cx="3982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-length blots/gels for 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标题 1">
            <a:extLst>
              <a:ext uri="{FF2B5EF4-FFF2-40B4-BE49-F238E27FC236}">
                <a16:creationId xmlns:a16="http://schemas.microsoft.com/office/drawing/2014/main" id="{D5143F5F-2F4D-45F4-8BB9-FEF72FA54927}"/>
              </a:ext>
            </a:extLst>
          </p:cNvPr>
          <p:cNvSpPr txBox="1">
            <a:spLocks/>
          </p:cNvSpPr>
          <p:nvPr/>
        </p:nvSpPr>
        <p:spPr>
          <a:xfrm>
            <a:off x="418421" y="0"/>
            <a:ext cx="549729" cy="84783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1632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C3963D3-F6D4-44CA-91FF-4640F2B03ED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314" t="16345" r="29238"/>
          <a:stretch/>
        </p:blipFill>
        <p:spPr>
          <a:xfrm>
            <a:off x="3567686" y="124613"/>
            <a:ext cx="6028865" cy="554651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AD1E6F33-DB19-49EF-977F-075472027770}"/>
              </a:ext>
            </a:extLst>
          </p:cNvPr>
          <p:cNvSpPr txBox="1"/>
          <p:nvPr/>
        </p:nvSpPr>
        <p:spPr>
          <a:xfrm>
            <a:off x="2463633" y="3358423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EAA0410-F3ED-4219-BD9D-B39CE2A401D1}"/>
              </a:ext>
            </a:extLst>
          </p:cNvPr>
          <p:cNvSpPr txBox="1"/>
          <p:nvPr/>
        </p:nvSpPr>
        <p:spPr>
          <a:xfrm>
            <a:off x="4172770" y="112599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6F44B81-9FBE-4FF5-9100-F46BAF58FBFF}"/>
              </a:ext>
            </a:extLst>
          </p:cNvPr>
          <p:cNvSpPr txBox="1"/>
          <p:nvPr/>
        </p:nvSpPr>
        <p:spPr>
          <a:xfrm>
            <a:off x="4885514" y="1130330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A8E6B88-44FF-473D-8050-7E0BCE6E02F8}"/>
              </a:ext>
            </a:extLst>
          </p:cNvPr>
          <p:cNvSpPr txBox="1"/>
          <p:nvPr/>
        </p:nvSpPr>
        <p:spPr>
          <a:xfrm>
            <a:off x="5538796" y="1125990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A5586AA-573F-41A1-98AB-657F96E5D5A7}"/>
              </a:ext>
            </a:extLst>
          </p:cNvPr>
          <p:cNvSpPr txBox="1"/>
          <p:nvPr/>
        </p:nvSpPr>
        <p:spPr>
          <a:xfrm>
            <a:off x="6135265" y="1125990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E68CF6A-B2A1-4A0E-AC27-3F975CB453AF}"/>
              </a:ext>
            </a:extLst>
          </p:cNvPr>
          <p:cNvSpPr txBox="1"/>
          <p:nvPr/>
        </p:nvSpPr>
        <p:spPr>
          <a:xfrm>
            <a:off x="6707219" y="1125990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29FCB08-159F-4F55-94D0-00BAF9CC380E}"/>
              </a:ext>
            </a:extLst>
          </p:cNvPr>
          <p:cNvSpPr txBox="1"/>
          <p:nvPr/>
        </p:nvSpPr>
        <p:spPr>
          <a:xfrm>
            <a:off x="4955303" y="765535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MMC-7721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68A13868-AC10-4AD1-BE67-3F88CBEF757C}"/>
              </a:ext>
            </a:extLst>
          </p:cNvPr>
          <p:cNvSpPr txBox="1"/>
          <p:nvPr/>
        </p:nvSpPr>
        <p:spPr>
          <a:xfrm>
            <a:off x="2463633" y="1959899"/>
            <a:ext cx="9749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20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E1D63A5-01F6-4F93-993B-69EA02DD7AE8}"/>
              </a:ext>
            </a:extLst>
          </p:cNvPr>
          <p:cNvSpPr txBox="1"/>
          <p:nvPr/>
        </p:nvSpPr>
        <p:spPr>
          <a:xfrm>
            <a:off x="2463633" y="2366567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1% O</a:t>
            </a:r>
            <a:r>
              <a:rPr lang="en-US" altLang="zh-CN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b="1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FDE9411-A424-4D3F-B9F4-A36353545863}"/>
              </a:ext>
            </a:extLst>
          </p:cNvPr>
          <p:cNvSpPr txBox="1"/>
          <p:nvPr/>
        </p:nvSpPr>
        <p:spPr>
          <a:xfrm>
            <a:off x="2463634" y="1128075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or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8D0DDE9-0C7F-44A9-93B7-0EB6F4122774}"/>
              </a:ext>
            </a:extLst>
          </p:cNvPr>
          <p:cNvSpPr txBox="1"/>
          <p:nvPr/>
        </p:nvSpPr>
        <p:spPr>
          <a:xfrm>
            <a:off x="2463633" y="1543987"/>
            <a:ext cx="9749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T-707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13EFA0E-3D13-4F1B-8515-FF8D9AF84306}"/>
              </a:ext>
            </a:extLst>
          </p:cNvPr>
          <p:cNvSpPr txBox="1"/>
          <p:nvPr/>
        </p:nvSpPr>
        <p:spPr>
          <a:xfrm>
            <a:off x="4172770" y="154398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A6A03EE-F63A-4745-A327-D99934606453}"/>
              </a:ext>
            </a:extLst>
          </p:cNvPr>
          <p:cNvSpPr txBox="1"/>
          <p:nvPr/>
        </p:nvSpPr>
        <p:spPr>
          <a:xfrm>
            <a:off x="4885514" y="154832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6D2F1D50-A19A-4B86-BC06-CE11C0C72238}"/>
              </a:ext>
            </a:extLst>
          </p:cNvPr>
          <p:cNvSpPr txBox="1"/>
          <p:nvPr/>
        </p:nvSpPr>
        <p:spPr>
          <a:xfrm>
            <a:off x="5538796" y="154398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BE630E1-0E5E-4F66-9A00-D5184FB16E6C}"/>
              </a:ext>
            </a:extLst>
          </p:cNvPr>
          <p:cNvSpPr txBox="1"/>
          <p:nvPr/>
        </p:nvSpPr>
        <p:spPr>
          <a:xfrm>
            <a:off x="6135265" y="154398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905A863-71EF-4EB9-8987-0FA2AFB475AF}"/>
              </a:ext>
            </a:extLst>
          </p:cNvPr>
          <p:cNvSpPr txBox="1"/>
          <p:nvPr/>
        </p:nvSpPr>
        <p:spPr>
          <a:xfrm>
            <a:off x="6707219" y="154398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AE2F21E-6C7E-46DD-A700-D582DFD28A4F}"/>
              </a:ext>
            </a:extLst>
          </p:cNvPr>
          <p:cNvSpPr txBox="1"/>
          <p:nvPr/>
        </p:nvSpPr>
        <p:spPr>
          <a:xfrm>
            <a:off x="4172770" y="1959899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61756BC8-29E7-45DB-A962-E0C598C7A612}"/>
              </a:ext>
            </a:extLst>
          </p:cNvPr>
          <p:cNvSpPr txBox="1"/>
          <p:nvPr/>
        </p:nvSpPr>
        <p:spPr>
          <a:xfrm>
            <a:off x="4885514" y="196423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A904170-2D9B-4C87-B122-6B12C34BC5BA}"/>
              </a:ext>
            </a:extLst>
          </p:cNvPr>
          <p:cNvSpPr txBox="1"/>
          <p:nvPr/>
        </p:nvSpPr>
        <p:spPr>
          <a:xfrm>
            <a:off x="5538796" y="1959899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DD8C397-A746-46B0-B338-71CE09BDE938}"/>
              </a:ext>
            </a:extLst>
          </p:cNvPr>
          <p:cNvSpPr txBox="1"/>
          <p:nvPr/>
        </p:nvSpPr>
        <p:spPr>
          <a:xfrm>
            <a:off x="6135265" y="1959899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8F2FF2E-A278-4053-AE63-A74EB545D6C6}"/>
              </a:ext>
            </a:extLst>
          </p:cNvPr>
          <p:cNvSpPr txBox="1"/>
          <p:nvPr/>
        </p:nvSpPr>
        <p:spPr>
          <a:xfrm>
            <a:off x="6707219" y="1959899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4ECB22F9-8E47-4571-AAC4-27056333A04C}"/>
              </a:ext>
            </a:extLst>
          </p:cNvPr>
          <p:cNvSpPr txBox="1"/>
          <p:nvPr/>
        </p:nvSpPr>
        <p:spPr>
          <a:xfrm>
            <a:off x="4172770" y="2362227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09E789FD-3DD9-43C0-9803-A1439D3AD4E6}"/>
              </a:ext>
            </a:extLst>
          </p:cNvPr>
          <p:cNvSpPr txBox="1"/>
          <p:nvPr/>
        </p:nvSpPr>
        <p:spPr>
          <a:xfrm>
            <a:off x="4885514" y="236656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2D9F78E0-92A5-4C81-AB2C-98FE2BC70B94}"/>
              </a:ext>
            </a:extLst>
          </p:cNvPr>
          <p:cNvSpPr txBox="1"/>
          <p:nvPr/>
        </p:nvSpPr>
        <p:spPr>
          <a:xfrm>
            <a:off x="5538796" y="236222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0ADA3A14-8CF1-4417-AB43-C9DCA9AF9F3E}"/>
              </a:ext>
            </a:extLst>
          </p:cNvPr>
          <p:cNvSpPr txBox="1"/>
          <p:nvPr/>
        </p:nvSpPr>
        <p:spPr>
          <a:xfrm>
            <a:off x="6135265" y="2362227"/>
            <a:ext cx="312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F701FFD-9AA4-43C6-A877-003F7C976116}"/>
              </a:ext>
            </a:extLst>
          </p:cNvPr>
          <p:cNvSpPr txBox="1"/>
          <p:nvPr/>
        </p:nvSpPr>
        <p:spPr>
          <a:xfrm>
            <a:off x="6707219" y="2362227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47E41ADA-55C5-4BE5-9F2D-81B0AAF8F9EB}"/>
              </a:ext>
            </a:extLst>
          </p:cNvPr>
          <p:cNvSpPr/>
          <p:nvPr/>
        </p:nvSpPr>
        <p:spPr>
          <a:xfrm>
            <a:off x="3817622" y="3185644"/>
            <a:ext cx="3755254" cy="71489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B6E23983-EC18-4CF3-AD7E-E1A03B4A5DC9}"/>
              </a:ext>
            </a:extLst>
          </p:cNvPr>
          <p:cNvSpPr txBox="1"/>
          <p:nvPr/>
        </p:nvSpPr>
        <p:spPr>
          <a:xfrm>
            <a:off x="3383219" y="6099568"/>
            <a:ext cx="39821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ull-length blots/gels for Figure 4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标题 1">
            <a:extLst>
              <a:ext uri="{FF2B5EF4-FFF2-40B4-BE49-F238E27FC236}">
                <a16:creationId xmlns:a16="http://schemas.microsoft.com/office/drawing/2014/main" id="{00C2AC27-59B0-4BD2-9B15-D082FC1F9828}"/>
              </a:ext>
            </a:extLst>
          </p:cNvPr>
          <p:cNvSpPr txBox="1">
            <a:spLocks/>
          </p:cNvSpPr>
          <p:nvPr/>
        </p:nvSpPr>
        <p:spPr>
          <a:xfrm>
            <a:off x="418421" y="0"/>
            <a:ext cx="549729" cy="847839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zh-CN" sz="4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4037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186</Words>
  <Application>Microsoft Office PowerPoint</Application>
  <PresentationFormat>宽屏</PresentationFormat>
  <Paragraphs>11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等线</vt:lpstr>
      <vt:lpstr>等线 Light</vt:lpstr>
      <vt:lpstr>Arial</vt:lpstr>
      <vt:lpstr>Office 主题​​</vt:lpstr>
      <vt:lpstr>Figure 1 original, full-length gel and blot 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3 original, full-length gel and blot </dc:title>
  <dc:creator>Chen Zibo</dc:creator>
  <cp:lastModifiedBy>Chen Zibo</cp:lastModifiedBy>
  <cp:revision>10</cp:revision>
  <dcterms:created xsi:type="dcterms:W3CDTF">2021-09-07T18:35:58Z</dcterms:created>
  <dcterms:modified xsi:type="dcterms:W3CDTF">2022-03-29T19:36:01Z</dcterms:modified>
</cp:coreProperties>
</file>